
<file path=[Content_Types].xml><?xml version="1.0" encoding="utf-8"?>
<Types xmlns="http://schemas.openxmlformats.org/package/2006/content-types">
  <Default Extension="jpeg" ContentType="image/jpeg"/>
  <Default Extension="wmf" ContentType="image/x-w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76" d="100"/>
          <a:sy n="76" d="100"/>
        </p:scale>
        <p:origin x="126" y="82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A1860C-0582-4C69-A385-D90D330690A3}" type="datetimeFigureOut">
              <a:rPr lang="en-US" smtClean="0"/>
              <a:t>1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E599B-47D9-4595-8C19-6556EB0589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05081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A1860C-0582-4C69-A385-D90D330690A3}" type="datetimeFigureOut">
              <a:rPr lang="en-US" smtClean="0"/>
              <a:t>1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E599B-47D9-4595-8C19-6556EB0589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41323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A1860C-0582-4C69-A385-D90D330690A3}" type="datetimeFigureOut">
              <a:rPr lang="en-US" smtClean="0"/>
              <a:t>1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E599B-47D9-4595-8C19-6556EB0589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89342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A1860C-0582-4C69-A385-D90D330690A3}" type="datetimeFigureOut">
              <a:rPr lang="en-US" smtClean="0"/>
              <a:t>1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E599B-47D9-4595-8C19-6556EB0589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54046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A1860C-0582-4C69-A385-D90D330690A3}" type="datetimeFigureOut">
              <a:rPr lang="en-US" smtClean="0"/>
              <a:t>1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E599B-47D9-4595-8C19-6556EB0589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73176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A1860C-0582-4C69-A385-D90D330690A3}" type="datetimeFigureOut">
              <a:rPr lang="en-US" smtClean="0"/>
              <a:t>1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E599B-47D9-4595-8C19-6556EB0589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45731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A1860C-0582-4C69-A385-D90D330690A3}" type="datetimeFigureOut">
              <a:rPr lang="en-US" smtClean="0"/>
              <a:t>1/3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E599B-47D9-4595-8C19-6556EB0589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16038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A1860C-0582-4C69-A385-D90D330690A3}" type="datetimeFigureOut">
              <a:rPr lang="en-US" smtClean="0"/>
              <a:t>1/3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E599B-47D9-4595-8C19-6556EB0589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52137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A1860C-0582-4C69-A385-D90D330690A3}" type="datetimeFigureOut">
              <a:rPr lang="en-US" smtClean="0"/>
              <a:t>1/3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E599B-47D9-4595-8C19-6556EB0589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5339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A1860C-0582-4C69-A385-D90D330690A3}" type="datetimeFigureOut">
              <a:rPr lang="en-US" smtClean="0"/>
              <a:t>1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E599B-47D9-4595-8C19-6556EB0589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15205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A1860C-0582-4C69-A385-D90D330690A3}" type="datetimeFigureOut">
              <a:rPr lang="en-US" smtClean="0"/>
              <a:t>1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E599B-47D9-4595-8C19-6556EB0589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83105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A1860C-0582-4C69-A385-D90D330690A3}" type="datetimeFigureOut">
              <a:rPr lang="en-US" smtClean="0"/>
              <a:t>1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EE599B-47D9-4595-8C19-6556EB0589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04874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wm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76350" y="444500"/>
            <a:ext cx="5448300" cy="636778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13875" y="75168"/>
            <a:ext cx="92765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upplementary Table </a:t>
            </a:r>
            <a:r>
              <a:rPr lang="en-US" b="1" dirty="0"/>
              <a:t>S1: Oligonucleotide sequences used in </a:t>
            </a:r>
            <a:r>
              <a:rPr lang="en-US" b="1" dirty="0" smtClean="0"/>
              <a:t>quantitative real-time </a:t>
            </a:r>
            <a:r>
              <a:rPr lang="en-US" b="1" dirty="0"/>
              <a:t>PCR analysis 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/>
          <a:srcRect l="-4911" t="-2473" r="25019" b="4947"/>
          <a:stretch/>
        </p:blipFill>
        <p:spPr>
          <a:xfrm>
            <a:off x="6591300" y="2182368"/>
            <a:ext cx="5473700" cy="25039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926084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53</TotalTime>
  <Words>12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AUB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elle Makoukji</dc:creator>
  <cp:lastModifiedBy>Joelle Makoukji</cp:lastModifiedBy>
  <cp:revision>42</cp:revision>
  <cp:lastPrinted>2018-09-04T09:43:10Z</cp:lastPrinted>
  <dcterms:created xsi:type="dcterms:W3CDTF">2018-08-31T07:45:28Z</dcterms:created>
  <dcterms:modified xsi:type="dcterms:W3CDTF">2019-01-30T10:21:28Z</dcterms:modified>
</cp:coreProperties>
</file>